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9" r:id="rId3"/>
    <p:sldId id="268" r:id="rId4"/>
    <p:sldId id="263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15"/>
    <p:restoredTop sz="96327"/>
  </p:normalViewPr>
  <p:slideViewPr>
    <p:cSldViewPr snapToGrid="0">
      <p:cViewPr varScale="1">
        <p:scale>
          <a:sx n="128" d="100"/>
          <a:sy n="128" d="100"/>
        </p:scale>
        <p:origin x="7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b702/Dropbox%20(Partners%20HealthCare)/Raja_personal%20Dropbox/PLOS%20ONE%20Correction/Excel%20data/Fig%201B%20made%20in%202013-(saved%20in%20new%20folder%202024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b702/Dropbox%20(Partners%20HealthCare)/Raja_personal%20Dropbox/PLOS%20ONE%20Correction/Excel%20data/Fig%201B%20made%20in%202013-(saved%20in%20new%20folder%202024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b702/Dropbox%20(Partners%20HealthCare)/Raja_personal%20Dropbox/PLOS%20ONE%20Correction/Excel%20data/CHO_715_DMSO_Cer_2B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b702/Dropbox%20(Partners%20HealthCare)/Raja_personal%20Dropbox/PLOS%20ONE%20Correction/Excel%20data/CHO_715_DMSO_Cer_2B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BECCA/palAPP%20BiFC_2.19.16_CER_GFP1-10_1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3072533580361277"/>
          <c:y val="0.10611739175061217"/>
          <c:w val="0.48456878184344593"/>
          <c:h val="0.664066042024076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1:$J$21</c:f>
                <c:numCache>
                  <c:formatCode>General</c:formatCode>
                  <c:ptCount val="2"/>
                  <c:pt idx="0">
                    <c:v>7.4851039594667084</c:v>
                  </c:pt>
                  <c:pt idx="1">
                    <c:v>1.8809324272546026</c:v>
                  </c:pt>
                </c:numCache>
              </c:numRef>
            </c:plus>
            <c:minus>
              <c:numRef>
                <c:f>Sheet1!$I$21:$J$21</c:f>
                <c:numCache>
                  <c:formatCode>General</c:formatCode>
                  <c:ptCount val="2"/>
                  <c:pt idx="0">
                    <c:v>7.4851039594667084</c:v>
                  </c:pt>
                  <c:pt idx="1">
                    <c:v>1.88093242725460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9:$J$19</c:f>
              <c:strCache>
                <c:ptCount val="2"/>
                <c:pt idx="0">
                  <c:v>palAPP</c:v>
                </c:pt>
                <c:pt idx="1">
                  <c:v>totAPP</c:v>
                </c:pt>
              </c:strCache>
            </c:strRef>
          </c:cat>
          <c:val>
            <c:numRef>
              <c:f>Sheet1!$I$20:$J$20</c:f>
              <c:numCache>
                <c:formatCode>General</c:formatCode>
                <c:ptCount val="2"/>
                <c:pt idx="0">
                  <c:v>90.755940115599728</c:v>
                </c:pt>
                <c:pt idx="1">
                  <c:v>19.3970830081553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6D-8F48-ADA8-25325BF65F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7939760"/>
        <c:axId val="568010288"/>
      </c:barChart>
      <c:catAx>
        <c:axId val="567939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010288"/>
        <c:crosses val="autoZero"/>
        <c:auto val="1"/>
        <c:lblAlgn val="ctr"/>
        <c:lblOffset val="100"/>
        <c:noMultiLvlLbl val="0"/>
      </c:catAx>
      <c:valAx>
        <c:axId val="56801028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793976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28683301508295"/>
          <c:y val="2.7777777777777776E-2"/>
          <c:w val="0.77623377459288967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4D-0647-AAB7-EAA6AF5CCBB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4D-0647-AAB7-EAA6AF5CCBB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6:$C$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7722424659454247</c:v>
                  </c:pt>
                </c:numCache>
              </c:numRef>
            </c:plus>
            <c:minus>
              <c:numRef>
                <c:f>Sheet1!$B$6:$C$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77224246594542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4:$C$4</c:f>
              <c:strCache>
                <c:ptCount val="2"/>
                <c:pt idx="0">
                  <c:v>cont</c:v>
                </c:pt>
                <c:pt idx="1">
                  <c:v>DHHC7</c:v>
                </c:pt>
              </c:strCache>
            </c:strRef>
          </c:cat>
          <c:val>
            <c:numRef>
              <c:f>Sheet1!$B$5:$C$5</c:f>
              <c:numCache>
                <c:formatCode>General</c:formatCode>
                <c:ptCount val="2"/>
                <c:pt idx="0">
                  <c:v>1</c:v>
                </c:pt>
                <c:pt idx="1">
                  <c:v>2.2893594308224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4D-0647-AAB7-EAA6AF5CCB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4802336"/>
        <c:axId val="545070944"/>
      </c:barChart>
      <c:catAx>
        <c:axId val="544802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5070944"/>
        <c:crosses val="autoZero"/>
        <c:auto val="1"/>
        <c:lblAlgn val="ctr"/>
        <c:lblOffset val="100"/>
        <c:noMultiLvlLbl val="0"/>
      </c:catAx>
      <c:valAx>
        <c:axId val="545070944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80233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18960109987425"/>
          <c:y val="7.3919359088401956E-2"/>
          <c:w val="0.80606842783705279"/>
          <c:h val="0.833820162870973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B$15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 w="381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47A-2346-A4B3-5968288D8A7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47A-2346-A4B3-5968288D8A75}"/>
              </c:ext>
            </c:extLst>
          </c:dPt>
          <c:dPt>
            <c:idx val="2"/>
            <c:invertIfNegative val="0"/>
            <c:bubble3D val="0"/>
            <c:spPr>
              <a:solidFill>
                <a:srgbClr val="5A0402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47A-2346-A4B3-5968288D8A75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16:$C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7.3471072671206547E-2</c:v>
                  </c:pt>
                  <c:pt idx="2">
                    <c:v>3.141393510807713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A$16:$A$18</c:f>
              <c:strCache>
                <c:ptCount val="3"/>
                <c:pt idx="0">
                  <c:v>DMSO</c:v>
                </c:pt>
                <c:pt idx="1">
                  <c:v>2-BP</c:v>
                </c:pt>
                <c:pt idx="2">
                  <c:v>Cer</c:v>
                </c:pt>
              </c:strCache>
            </c:strRef>
          </c:cat>
          <c:val>
            <c:numRef>
              <c:f>Sheet2!$B$16:$B$18</c:f>
              <c:numCache>
                <c:formatCode>General</c:formatCode>
                <c:ptCount val="3"/>
                <c:pt idx="0">
                  <c:v>1</c:v>
                </c:pt>
                <c:pt idx="1">
                  <c:v>0.46001981230727579</c:v>
                </c:pt>
                <c:pt idx="2">
                  <c:v>0.41620860507732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47A-2346-A4B3-5968288D8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507847152"/>
        <c:axId val="1507849424"/>
      </c:barChart>
      <c:catAx>
        <c:axId val="1507847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7849424"/>
        <c:crosses val="autoZero"/>
        <c:auto val="0"/>
        <c:lblAlgn val="ctr"/>
        <c:lblOffset val="100"/>
        <c:noMultiLvlLbl val="0"/>
      </c:catAx>
      <c:valAx>
        <c:axId val="1507849424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07847152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737910279918739E-2"/>
          <c:y val="6.9129619192746544E-2"/>
          <c:w val="0.82964406036628513"/>
          <c:h val="0.861194489271412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723-CE4D-A772-85D13487A208}"/>
              </c:ext>
            </c:extLst>
          </c:dPt>
          <c:dPt>
            <c:idx val="1"/>
            <c:invertIfNegative val="0"/>
            <c:bubble3D val="0"/>
            <c:spPr>
              <a:solidFill>
                <a:srgbClr val="00000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723-CE4D-A772-85D13487A20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723-CE4D-A772-85D13487A208}"/>
              </c:ext>
            </c:extLst>
          </c:dPt>
          <c:dPt>
            <c:idx val="3"/>
            <c:invertIfNegative val="0"/>
            <c:bubble3D val="0"/>
            <c:spPr>
              <a:solidFill>
                <a:srgbClr val="6F0300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723-CE4D-A772-85D13487A208}"/>
              </c:ext>
            </c:extLst>
          </c:dPt>
          <c:errBars>
            <c:errBarType val="plus"/>
            <c:errValType val="cust"/>
            <c:noEndCap val="0"/>
            <c:plus>
              <c:numRef>
                <c:f>Sheet3!$L$9:$L$12</c:f>
                <c:numCache>
                  <c:formatCode>General</c:formatCode>
                  <c:ptCount val="4"/>
                  <c:pt idx="0">
                    <c:v>5.8347134891098197E-2</c:v>
                  </c:pt>
                  <c:pt idx="1">
                    <c:v>0.12541516130879501</c:v>
                  </c:pt>
                  <c:pt idx="2">
                    <c:v>5.7958256098678496E-2</c:v>
                  </c:pt>
                  <c:pt idx="3">
                    <c:v>9.48719464301457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J$9:$J$12</c:f>
              <c:strCache>
                <c:ptCount val="4"/>
                <c:pt idx="0">
                  <c:v>Donor</c:v>
                </c:pt>
                <c:pt idx="1">
                  <c:v>DMSO</c:v>
                </c:pt>
                <c:pt idx="2">
                  <c:v>2-BP</c:v>
                </c:pt>
                <c:pt idx="3">
                  <c:v>Cer</c:v>
                </c:pt>
              </c:strCache>
            </c:strRef>
          </c:cat>
          <c:val>
            <c:numRef>
              <c:f>Sheet3!$K$9:$K$12</c:f>
              <c:numCache>
                <c:formatCode>General</c:formatCode>
                <c:ptCount val="4"/>
                <c:pt idx="0">
                  <c:v>2.6524899999999998</c:v>
                </c:pt>
                <c:pt idx="1">
                  <c:v>1.30158111111111</c:v>
                </c:pt>
                <c:pt idx="2">
                  <c:v>1.7252666666666701</c:v>
                </c:pt>
                <c:pt idx="3">
                  <c:v>1.76115222222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723-CE4D-A772-85D13487A2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8"/>
        <c:overlap val="-27"/>
        <c:axId val="1109576000"/>
        <c:axId val="1148475072"/>
      </c:barChart>
      <c:catAx>
        <c:axId val="1109576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48475072"/>
        <c:crosses val="autoZero"/>
        <c:auto val="1"/>
        <c:lblAlgn val="ctr"/>
        <c:lblOffset val="100"/>
        <c:noMultiLvlLbl val="0"/>
      </c:catAx>
      <c:valAx>
        <c:axId val="1148475072"/>
        <c:scaling>
          <c:orientation val="minMax"/>
        </c:scaling>
        <c:delete val="0"/>
        <c:axPos val="l"/>
        <c:numFmt formatCode="#,##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9576000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55273351519641"/>
          <c:y val="4.8372500246306169E-2"/>
          <c:w val="0.70436556567876329"/>
          <c:h val="0.87684361437290448"/>
        </c:manualLayout>
      </c:layout>
      <c:lineChart>
        <c:grouping val="standard"/>
        <c:varyColors val="0"/>
        <c:ser>
          <c:idx val="0"/>
          <c:order val="0"/>
          <c:spPr>
            <a:ln w="508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val>
            <c:numRef>
              <c:f>Sheet1!$H$13:$K$13</c:f>
              <c:numCache>
                <c:formatCode>General</c:formatCode>
                <c:ptCount val="4"/>
                <c:pt idx="0">
                  <c:v>100</c:v>
                </c:pt>
                <c:pt idx="1">
                  <c:v>80.887162116246003</c:v>
                </c:pt>
                <c:pt idx="2">
                  <c:v>39.447476506988899</c:v>
                </c:pt>
                <c:pt idx="3">
                  <c:v>0.239837586040326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4D0-B946-B8BA-CB5DAE89573F}"/>
            </c:ext>
          </c:extLst>
        </c:ser>
        <c:ser>
          <c:idx val="1"/>
          <c:order val="1"/>
          <c:spPr>
            <a:ln w="508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H$15:$K$15</c:f>
                <c:numCache>
                  <c:formatCode>General</c:formatCode>
                  <c:ptCount val="4"/>
                  <c:pt idx="0">
                    <c:v>12.412409781491114</c:v>
                  </c:pt>
                  <c:pt idx="1">
                    <c:v>13.090184593887669</c:v>
                  </c:pt>
                  <c:pt idx="2">
                    <c:v>22.100816572403058</c:v>
                  </c:pt>
                  <c:pt idx="3">
                    <c:v>13.072034265597473</c:v>
                  </c:pt>
                </c:numCache>
              </c:numRef>
            </c:plus>
            <c:minus>
              <c:numRef>
                <c:f>Sheet1!$H$15:$K$15</c:f>
                <c:numCache>
                  <c:formatCode>General</c:formatCode>
                  <c:ptCount val="4"/>
                  <c:pt idx="0">
                    <c:v>12.412409781491114</c:v>
                  </c:pt>
                  <c:pt idx="1">
                    <c:v>13.090184593887669</c:v>
                  </c:pt>
                  <c:pt idx="2">
                    <c:v>22.100816572403058</c:v>
                  </c:pt>
                  <c:pt idx="3">
                    <c:v>13.0720342655974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14:$K$14</c:f>
              <c:numCache>
                <c:formatCode>General</c:formatCode>
                <c:ptCount val="4"/>
                <c:pt idx="0">
                  <c:v>100</c:v>
                </c:pt>
                <c:pt idx="1">
                  <c:v>87.278813964610222</c:v>
                </c:pt>
                <c:pt idx="2">
                  <c:v>91.343854615016724</c:v>
                </c:pt>
                <c:pt idx="3">
                  <c:v>86.9230033476805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4D0-B946-B8BA-CB5DAE895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85326064"/>
        <c:axId val="1601740624"/>
      </c:lineChart>
      <c:catAx>
        <c:axId val="1585326064"/>
        <c:scaling>
          <c:orientation val="minMax"/>
        </c:scaling>
        <c:delete val="1"/>
        <c:axPos val="b"/>
        <c:numFmt formatCode="0" sourceLinked="0"/>
        <c:majorTickMark val="none"/>
        <c:minorTickMark val="none"/>
        <c:tickLblPos val="nextTo"/>
        <c:crossAx val="1601740624"/>
        <c:crosses val="autoZero"/>
        <c:auto val="1"/>
        <c:lblAlgn val="ctr"/>
        <c:lblOffset val="100"/>
        <c:tickLblSkip val="25"/>
        <c:noMultiLvlLbl val="0"/>
      </c:catAx>
      <c:valAx>
        <c:axId val="1601740624"/>
        <c:scaling>
          <c:orientation val="minMax"/>
          <c:max val="120"/>
          <c:min val="0"/>
        </c:scaling>
        <c:delete val="0"/>
        <c:axPos val="l"/>
        <c:majorGridlines>
          <c:spPr>
            <a:ln w="1270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5326064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1E647-AC95-1040-15D3-93816744B9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4ECC4E-8EE2-F087-3719-371180EBCE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F63FC3-3048-405B-328E-F542E68BA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EBB56-05F6-8F79-B4B5-EF3ED8259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DB1EC8-F754-B296-BA67-85E21A67F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670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F6FC0-0DB7-8EB3-1012-7E10BDB2F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9881AB-2A2F-29F2-7D75-9B724F5762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5AD780-A505-3179-696A-51D44905A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733059-428A-3CAF-103B-9622E3ED1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B7DA2-134F-A3EC-5B4F-E9DDFF0C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6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2E4EC5-9D3F-8004-EFC3-582D47E73E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4A36F0-148B-5D2D-365D-7E6199297C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B0D4E8-9AF9-3771-94F2-74348AFBA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14E09-F885-01E1-72D0-0F4FCB6FC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BDD60-F5A1-493F-EFA8-5956162B3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63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3115B6-3D21-D250-6979-98BEA3E20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26B9F8-9480-B3A1-F76A-07EF89784E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BD722-867A-549F-ABA7-FED89704D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C164B-B0BE-AD89-83A8-9B09DF355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BA3B9-FF46-3B97-3FB2-621AD7E3D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708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E15D4-DB98-7D4F-E0A0-FB64EBCE1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7CE999-52EF-3364-FB63-FD14BA39AF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A370EC-4CA0-10CD-9EB3-B98726A56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D25E66-08BF-3F38-A89C-B6F727E9F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131653-BE19-E2E3-C8A8-F2A4A5A68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789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52EF5-D593-4C7B-78BD-4CC394D12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7C3354-B478-F323-FF3B-1FC7A747B8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765379-925B-9F7F-8EB3-9764CF4C54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FE5F64-D97F-AEFD-DD85-EDC7837DB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C83C97-A95E-859B-0BCE-EE320A7A8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FA286E-7385-83FF-B5F5-E77C49F72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275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DFA9F-1776-5934-0E84-A8ED00F66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442473-3FE6-C55C-723D-20573CD88C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353896-B0A6-70B4-ED3D-0A49B68CB2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03F1F1-D9BC-7E65-E552-2126A3600E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C140F6-41B3-E87A-FA0D-ABE5F23EF4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24EF4B-5785-665A-4DE4-020935E8A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436176-C3BC-1AA2-CDBE-47DB46AC6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629675-D976-AFE1-5687-FE84BC08C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812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56CEA-57A8-5FFE-EE47-8CF9BD355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A7B539-C9D5-C6E2-08F6-2D804CE60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83B609-73D9-BFED-D299-7F6A5E3C1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17054E-83DB-E270-FA56-F1583405C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631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B65006-44D1-5BCE-3F4E-BC4CDDB81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159DFA-6C27-414B-5BAA-EE898E7CB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0F88D2-CEF1-2D3B-013C-39378B7C3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01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94ACC-CC02-5A11-B1AE-1981FBB90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2FB206-7D37-C683-99DA-4E34A2D049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BAEE23-6CAB-F21C-C008-FA6296D0A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972FAB-47AE-143D-9263-45AC7B0BB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19759A-46C1-33B7-F8C2-444FA8CE6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603425-3311-7CA2-BC23-6161CAAC7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973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90FF92-69C7-D025-2E5F-A989FFBEEB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FD6953-D904-101C-E1A6-7CC0E0A70F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42743E-4178-ABF8-2932-65DC58CA4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97D909-1035-C26D-291C-2368F634D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952795-D6C8-04FE-60A8-FB24CBE0F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4775EA-F4FA-2071-0B84-CFBF60685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578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FB7F11-0C6D-EE74-CC9A-1D99E25F9D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CEAE97-B780-5AFF-B83F-F8CA77960C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B8A1CB-BEA3-3A93-7BFE-98DD8A419F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40A3A-F570-3640-9C2F-42352223BDCD}" type="datetimeFigureOut">
              <a:rPr lang="en-US" smtClean="0"/>
              <a:t>2/1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97FF5-6887-F4E8-4AAC-150AB6106C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3CE06C-A4F1-C6FB-7937-341662461B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BFFF0-BA6F-F742-83C5-582217F480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157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22D726-17B3-DAF9-AAAB-1F67F88B9C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EAFDD7C6-0B3E-8D13-F825-2AE7086918DD}"/>
              </a:ext>
            </a:extLst>
          </p:cNvPr>
          <p:cNvSpPr txBox="1"/>
          <p:nvPr/>
        </p:nvSpPr>
        <p:spPr>
          <a:xfrm>
            <a:off x="3521290" y="1118579"/>
            <a:ext cx="1992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iginal data for Figure 1C</a:t>
            </a: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22CBD313-AAFA-890E-6A64-B722903CF3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8847419"/>
              </p:ext>
            </p:extLst>
          </p:nvPr>
        </p:nvGraphicFramePr>
        <p:xfrm>
          <a:off x="3721685" y="1527271"/>
          <a:ext cx="3321913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4559">
                  <a:extLst>
                    <a:ext uri="{9D8B030D-6E8A-4147-A177-3AD203B41FA5}">
                      <a16:colId xmlns:a16="http://schemas.microsoft.com/office/drawing/2014/main" val="2643416549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2500113034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2389569035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2641557578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2095426769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1924853624"/>
                    </a:ext>
                  </a:extLst>
                </a:gridCol>
                <a:gridCol w="474559">
                  <a:extLst>
                    <a:ext uri="{9D8B030D-6E8A-4147-A177-3AD203B41FA5}">
                      <a16:colId xmlns:a16="http://schemas.microsoft.com/office/drawing/2014/main" val="4289973638"/>
                    </a:ext>
                  </a:extLst>
                </a:gridCol>
              </a:tblGrid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otAPP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alAPP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6358013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7.92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0.8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812941616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4.0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1.32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28333703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872112404"/>
                  </a:ext>
                </a:extLst>
              </a:tr>
              <a:tr h="175222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ot/palAPPV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088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792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4480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019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792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64088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71406685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ot/palAPPy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0860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089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704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990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4309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6002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55035562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2.189927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4.041773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6.68611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8.067062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727103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94066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1012376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03847930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645936619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571706615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ercent (%)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ercent(%)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07089697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2.189927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8.067062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74295824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4.041773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727103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85638411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6.03611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94066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03302429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0.755940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9.39708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48488342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4851039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.8809324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10848646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50573475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655915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alAPP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totAPP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78952387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v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0.755940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9.39708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6468069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EM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4851039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.8809324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15355216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3009538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7144435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335601699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803464049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17967294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95065842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155861020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85302744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5978490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74266717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018389113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14742807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06068065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3617882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74740793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65807497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70290826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858647152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44796082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05277599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54822675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34461328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550966021"/>
                  </a:ext>
                </a:extLst>
              </a:tr>
              <a:tr h="94912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79029602"/>
                  </a:ext>
                </a:extLst>
              </a:tr>
            </a:tbl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070601D0-1BD8-1ED1-B350-BBFBE588C0C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37401707"/>
              </p:ext>
            </p:extLst>
          </p:nvPr>
        </p:nvGraphicFramePr>
        <p:xfrm>
          <a:off x="4524194" y="2607884"/>
          <a:ext cx="2698750" cy="3409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9F87318-E775-C304-1ED4-B55C3469118E}"/>
              </a:ext>
            </a:extLst>
          </p:cNvPr>
          <p:cNvSpPr txBox="1"/>
          <p:nvPr/>
        </p:nvSpPr>
        <p:spPr>
          <a:xfrm>
            <a:off x="636693" y="284480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C</a:t>
            </a:r>
          </a:p>
        </p:txBody>
      </p:sp>
    </p:spTree>
    <p:extLst>
      <p:ext uri="{BB962C8B-B14F-4D97-AF65-F5344CB8AC3E}">
        <p14:creationId xmlns:p14="http://schemas.microsoft.com/office/powerpoint/2010/main" val="1929997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625DB29-A632-EF50-64A9-29850F8881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105234"/>
              </p:ext>
            </p:extLst>
          </p:nvPr>
        </p:nvGraphicFramePr>
        <p:xfrm>
          <a:off x="4244597" y="1253338"/>
          <a:ext cx="2837832" cy="43513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2972">
                  <a:extLst>
                    <a:ext uri="{9D8B030D-6E8A-4147-A177-3AD203B41FA5}">
                      <a16:colId xmlns:a16="http://schemas.microsoft.com/office/drawing/2014/main" val="3782395267"/>
                    </a:ext>
                  </a:extLst>
                </a:gridCol>
                <a:gridCol w="472972">
                  <a:extLst>
                    <a:ext uri="{9D8B030D-6E8A-4147-A177-3AD203B41FA5}">
                      <a16:colId xmlns:a16="http://schemas.microsoft.com/office/drawing/2014/main" val="2218027319"/>
                    </a:ext>
                  </a:extLst>
                </a:gridCol>
                <a:gridCol w="472972">
                  <a:extLst>
                    <a:ext uri="{9D8B030D-6E8A-4147-A177-3AD203B41FA5}">
                      <a16:colId xmlns:a16="http://schemas.microsoft.com/office/drawing/2014/main" val="1477512642"/>
                    </a:ext>
                  </a:extLst>
                </a:gridCol>
                <a:gridCol w="472972">
                  <a:extLst>
                    <a:ext uri="{9D8B030D-6E8A-4147-A177-3AD203B41FA5}">
                      <a16:colId xmlns:a16="http://schemas.microsoft.com/office/drawing/2014/main" val="1922312938"/>
                    </a:ext>
                  </a:extLst>
                </a:gridCol>
                <a:gridCol w="472972">
                  <a:extLst>
                    <a:ext uri="{9D8B030D-6E8A-4147-A177-3AD203B41FA5}">
                      <a16:colId xmlns:a16="http://schemas.microsoft.com/office/drawing/2014/main" val="1688798183"/>
                    </a:ext>
                  </a:extLst>
                </a:gridCol>
                <a:gridCol w="472972">
                  <a:extLst>
                    <a:ext uri="{9D8B030D-6E8A-4147-A177-3AD203B41FA5}">
                      <a16:colId xmlns:a16="http://schemas.microsoft.com/office/drawing/2014/main" val="835386280"/>
                    </a:ext>
                  </a:extLst>
                </a:gridCol>
              </a:tblGrid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ont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DHHC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982248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2893594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6105992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1772242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5062919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66012460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51514727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799415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74882184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11191491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88788169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11977715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43064990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5073472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98250534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8523454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84237030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89662932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99245173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6955177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1412434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7448231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69812918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58753514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09634354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13800552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99537746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1317843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8257035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08844923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06737311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57846191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40336206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9381333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4940950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35521277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3368708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ont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DHHC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ont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DHHC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87006847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2381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61140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529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2614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7149288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902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4204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497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4351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045302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852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26108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61119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582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259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1504926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12828708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47574236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7538023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1229936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85846594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26934232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4866062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Av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28935943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65162031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SEM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17722425</a:t>
                      </a:r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2033689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620581309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B480F94-E227-AE1A-ECDF-0B5524FB2AB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77369698"/>
              </p:ext>
            </p:extLst>
          </p:nvPr>
        </p:nvGraphicFramePr>
        <p:xfrm>
          <a:off x="4244597" y="1791662"/>
          <a:ext cx="23304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A476216-E813-BE25-A71B-7A9C5F5521D0}"/>
              </a:ext>
            </a:extLst>
          </p:cNvPr>
          <p:cNvSpPr txBox="1"/>
          <p:nvPr/>
        </p:nvSpPr>
        <p:spPr>
          <a:xfrm>
            <a:off x="636693" y="653812"/>
            <a:ext cx="1992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iginal data for Figure 3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3A819E-4565-27A4-9606-53E40D4CBBDA}"/>
              </a:ext>
            </a:extLst>
          </p:cNvPr>
          <p:cNvSpPr txBox="1"/>
          <p:nvPr/>
        </p:nvSpPr>
        <p:spPr>
          <a:xfrm>
            <a:off x="636693" y="284480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C</a:t>
            </a:r>
          </a:p>
        </p:txBody>
      </p:sp>
    </p:spTree>
    <p:extLst>
      <p:ext uri="{BB962C8B-B14F-4D97-AF65-F5344CB8AC3E}">
        <p14:creationId xmlns:p14="http://schemas.microsoft.com/office/powerpoint/2010/main" val="673906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22D726-17B3-DAF9-AAAB-1F67F88B9C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2483CD09-C0D8-A29F-77B9-E65C5305169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44098172"/>
              </p:ext>
            </p:extLst>
          </p:nvPr>
        </p:nvGraphicFramePr>
        <p:xfrm>
          <a:off x="3910231" y="3578021"/>
          <a:ext cx="3760150" cy="29806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3B04B72C-091A-C99A-8907-DFF5313036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9853201"/>
              </p:ext>
            </p:extLst>
          </p:nvPr>
        </p:nvGraphicFramePr>
        <p:xfrm>
          <a:off x="564733" y="885549"/>
          <a:ext cx="10515600" cy="25633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7658">
                  <a:extLst>
                    <a:ext uri="{9D8B030D-6E8A-4147-A177-3AD203B41FA5}">
                      <a16:colId xmlns:a16="http://schemas.microsoft.com/office/drawing/2014/main" val="2796580575"/>
                    </a:ext>
                  </a:extLst>
                </a:gridCol>
                <a:gridCol w="642470">
                  <a:extLst>
                    <a:ext uri="{9D8B030D-6E8A-4147-A177-3AD203B41FA5}">
                      <a16:colId xmlns:a16="http://schemas.microsoft.com/office/drawing/2014/main" val="95692872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1877364606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218501023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2414335090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3782110798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1737826507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607293864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1960961702"/>
                    </a:ext>
                  </a:extLst>
                </a:gridCol>
                <a:gridCol w="828983">
                  <a:extLst>
                    <a:ext uri="{9D8B030D-6E8A-4147-A177-3AD203B41FA5}">
                      <a16:colId xmlns:a16="http://schemas.microsoft.com/office/drawing/2014/main" val="1110996732"/>
                    </a:ext>
                  </a:extLst>
                </a:gridCol>
                <a:gridCol w="809110">
                  <a:extLst>
                    <a:ext uri="{9D8B030D-6E8A-4147-A177-3AD203B41FA5}">
                      <a16:colId xmlns:a16="http://schemas.microsoft.com/office/drawing/2014/main" val="3297555143"/>
                    </a:ext>
                  </a:extLst>
                </a:gridCol>
                <a:gridCol w="760848">
                  <a:extLst>
                    <a:ext uri="{9D8B030D-6E8A-4147-A177-3AD203B41FA5}">
                      <a16:colId xmlns:a16="http://schemas.microsoft.com/office/drawing/2014/main" val="3565929568"/>
                    </a:ext>
                  </a:extLst>
                </a:gridCol>
                <a:gridCol w="672839">
                  <a:extLst>
                    <a:ext uri="{9D8B030D-6E8A-4147-A177-3AD203B41FA5}">
                      <a16:colId xmlns:a16="http://schemas.microsoft.com/office/drawing/2014/main" val="927943232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2091400641"/>
                    </a:ext>
                  </a:extLst>
                </a:gridCol>
                <a:gridCol w="681356">
                  <a:extLst>
                    <a:ext uri="{9D8B030D-6E8A-4147-A177-3AD203B41FA5}">
                      <a16:colId xmlns:a16="http://schemas.microsoft.com/office/drawing/2014/main" val="1708685955"/>
                    </a:ext>
                  </a:extLst>
                </a:gridCol>
                <a:gridCol w="604704">
                  <a:extLst>
                    <a:ext uri="{9D8B030D-6E8A-4147-A177-3AD203B41FA5}">
                      <a16:colId xmlns:a16="http://schemas.microsoft.com/office/drawing/2014/main" val="3918243925"/>
                    </a:ext>
                  </a:extLst>
                </a:gridCol>
              </a:tblGrid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282654955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ackgroun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128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im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ot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74276888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e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292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860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3975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3132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0368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8260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501480214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2-B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370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117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730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1921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8548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9638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87379842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418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278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124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8232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2656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0633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58431040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im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ot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im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ot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78005667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MS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.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3.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45026488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2-B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576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300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059240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467852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70149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240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404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4324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963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72763978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504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32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970379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934336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72305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759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417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8111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258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06210125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31286027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685212350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84937232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MSO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976039419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2-B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001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734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04499862"/>
                  </a:ext>
                </a:extLst>
              </a:tr>
              <a:tr h="170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1620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314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73749992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89188557-DC96-4133-68CF-DF8A11B69865}"/>
              </a:ext>
            </a:extLst>
          </p:cNvPr>
          <p:cNvSpPr txBox="1"/>
          <p:nvPr/>
        </p:nvSpPr>
        <p:spPr>
          <a:xfrm>
            <a:off x="284480" y="463064"/>
            <a:ext cx="20176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iginal data for Figure 4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3A17721-688A-8135-40EC-43008862A6F5}"/>
              </a:ext>
            </a:extLst>
          </p:cNvPr>
          <p:cNvSpPr txBox="1"/>
          <p:nvPr/>
        </p:nvSpPr>
        <p:spPr>
          <a:xfrm>
            <a:off x="284480" y="14224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</a:p>
        </p:txBody>
      </p:sp>
    </p:spTree>
    <p:extLst>
      <p:ext uri="{BB962C8B-B14F-4D97-AF65-F5344CB8AC3E}">
        <p14:creationId xmlns:p14="http://schemas.microsoft.com/office/powerpoint/2010/main" val="4730280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22D726-17B3-DAF9-AAAB-1F67F88B9C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B2529B6-291D-966A-C4EB-1FC9113498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0997185"/>
              </p:ext>
            </p:extLst>
          </p:nvPr>
        </p:nvGraphicFramePr>
        <p:xfrm>
          <a:off x="369533" y="1112140"/>
          <a:ext cx="4808752" cy="551108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3858">
                  <a:extLst>
                    <a:ext uri="{9D8B030D-6E8A-4147-A177-3AD203B41FA5}">
                      <a16:colId xmlns:a16="http://schemas.microsoft.com/office/drawing/2014/main" val="3237936821"/>
                    </a:ext>
                  </a:extLst>
                </a:gridCol>
                <a:gridCol w="787749">
                  <a:extLst>
                    <a:ext uri="{9D8B030D-6E8A-4147-A177-3AD203B41FA5}">
                      <a16:colId xmlns:a16="http://schemas.microsoft.com/office/drawing/2014/main" val="3926291587"/>
                    </a:ext>
                  </a:extLst>
                </a:gridCol>
                <a:gridCol w="923787">
                  <a:extLst>
                    <a:ext uri="{9D8B030D-6E8A-4147-A177-3AD203B41FA5}">
                      <a16:colId xmlns:a16="http://schemas.microsoft.com/office/drawing/2014/main" val="993708163"/>
                    </a:ext>
                  </a:extLst>
                </a:gridCol>
                <a:gridCol w="847859">
                  <a:extLst>
                    <a:ext uri="{9D8B030D-6E8A-4147-A177-3AD203B41FA5}">
                      <a16:colId xmlns:a16="http://schemas.microsoft.com/office/drawing/2014/main" val="4135821634"/>
                    </a:ext>
                  </a:extLst>
                </a:gridCol>
                <a:gridCol w="901641">
                  <a:extLst>
                    <a:ext uri="{9D8B030D-6E8A-4147-A177-3AD203B41FA5}">
                      <a16:colId xmlns:a16="http://schemas.microsoft.com/office/drawing/2014/main" val="614916499"/>
                    </a:ext>
                  </a:extLst>
                </a:gridCol>
                <a:gridCol w="673858">
                  <a:extLst>
                    <a:ext uri="{9D8B030D-6E8A-4147-A177-3AD203B41FA5}">
                      <a16:colId xmlns:a16="http://schemas.microsoft.com/office/drawing/2014/main" val="423870001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verag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ono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MS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-BP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600759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70.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50.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11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41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107644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96.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39.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09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96.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75139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95.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01.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40.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910.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7553849"/>
                  </a:ext>
                </a:extLst>
              </a:tr>
              <a:tr h="2278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04.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70.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72.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907.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353302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762.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14.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45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55.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400651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21.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88.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07.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07.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516770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3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11.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42.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595.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01.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03784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3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06.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77.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28.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38.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9042655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3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704.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30.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18.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92.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868411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57070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52.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01.58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25.2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61.15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80805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8.347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5.415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7.958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4.8719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55804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07883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652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0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25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61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79647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58.34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5.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7.9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4.8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00738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430294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4093894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26998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v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M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25834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52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8.3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Don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.65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105259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301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5.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DMS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.30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2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7592324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25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7.9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2-B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72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710332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61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4.8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76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500253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0425393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9405463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89545269"/>
                  </a:ext>
                </a:extLst>
              </a:tr>
            </a:tbl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10302A6A-8AA0-942C-EE29-601BFC52FD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6062282"/>
              </p:ext>
            </p:extLst>
          </p:nvPr>
        </p:nvGraphicFramePr>
        <p:xfrm>
          <a:off x="5277139" y="1112141"/>
          <a:ext cx="6054007" cy="55110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1A14BFA6-FC67-BDC2-6E92-7E31ACB5DD62}"/>
              </a:ext>
            </a:extLst>
          </p:cNvPr>
          <p:cNvSpPr txBox="1"/>
          <p:nvPr/>
        </p:nvSpPr>
        <p:spPr>
          <a:xfrm>
            <a:off x="329907" y="546348"/>
            <a:ext cx="2392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riginal graph for Figure 4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A93B57-60E4-1405-1C8F-A55BFAB1CE28}"/>
              </a:ext>
            </a:extLst>
          </p:cNvPr>
          <p:cNvSpPr txBox="1"/>
          <p:nvPr/>
        </p:nvSpPr>
        <p:spPr>
          <a:xfrm>
            <a:off x="329907" y="17701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</a:p>
        </p:txBody>
      </p:sp>
    </p:spTree>
    <p:extLst>
      <p:ext uri="{BB962C8B-B14F-4D97-AF65-F5344CB8AC3E}">
        <p14:creationId xmlns:p14="http://schemas.microsoft.com/office/powerpoint/2010/main" val="18852982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22D726-17B3-DAF9-AAAB-1F67F88B9C0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4C6FEEF-8B55-5B12-D637-DBB1EBA6AA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6616270"/>
              </p:ext>
            </p:extLst>
          </p:nvPr>
        </p:nvGraphicFramePr>
        <p:xfrm>
          <a:off x="5128590" y="685800"/>
          <a:ext cx="6221897" cy="5476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5B06682-FF1E-4097-CD06-6FFD40E7F2D4}"/>
              </a:ext>
            </a:extLst>
          </p:cNvPr>
          <p:cNvSpPr txBox="1"/>
          <p:nvPr/>
        </p:nvSpPr>
        <p:spPr>
          <a:xfrm>
            <a:off x="6157388" y="5800532"/>
            <a:ext cx="3850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     25                       50                      100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3D8BB05-928A-3D8A-D17B-054D7357C2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9959298"/>
              </p:ext>
            </p:extLst>
          </p:nvPr>
        </p:nvGraphicFramePr>
        <p:xfrm>
          <a:off x="761999" y="1163320"/>
          <a:ext cx="3555999" cy="304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0466">
                  <a:extLst>
                    <a:ext uri="{9D8B030D-6E8A-4147-A177-3AD203B41FA5}">
                      <a16:colId xmlns:a16="http://schemas.microsoft.com/office/drawing/2014/main" val="2932703062"/>
                    </a:ext>
                  </a:extLst>
                </a:gridCol>
                <a:gridCol w="576072">
                  <a:extLst>
                    <a:ext uri="{9D8B030D-6E8A-4147-A177-3AD203B41FA5}">
                      <a16:colId xmlns:a16="http://schemas.microsoft.com/office/drawing/2014/main" val="4086401352"/>
                    </a:ext>
                  </a:extLst>
                </a:gridCol>
                <a:gridCol w="673269">
                  <a:extLst>
                    <a:ext uri="{9D8B030D-6E8A-4147-A177-3AD203B41FA5}">
                      <a16:colId xmlns:a16="http://schemas.microsoft.com/office/drawing/2014/main" val="4288459505"/>
                    </a:ext>
                  </a:extLst>
                </a:gridCol>
                <a:gridCol w="673269">
                  <a:extLst>
                    <a:ext uri="{9D8B030D-6E8A-4147-A177-3AD203B41FA5}">
                      <a16:colId xmlns:a16="http://schemas.microsoft.com/office/drawing/2014/main" val="2188159207"/>
                    </a:ext>
                  </a:extLst>
                </a:gridCol>
                <a:gridCol w="862923">
                  <a:extLst>
                    <a:ext uri="{9D8B030D-6E8A-4147-A177-3AD203B41FA5}">
                      <a16:colId xmlns:a16="http://schemas.microsoft.com/office/drawing/2014/main" val="169304167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0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0 ug/m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5 ug/m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0 ug/m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00 ug/m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33771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1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427046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3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604056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1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535051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1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1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654839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3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1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943915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852332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G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3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977835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H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0.2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118713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8525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55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81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74055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1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71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67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2767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7664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142933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613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81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8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271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437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24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42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77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34167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18154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backgroun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27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41260371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D97CA52-672E-CA00-8A9D-CDF1DFAD1A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1731558"/>
              </p:ext>
            </p:extLst>
          </p:nvPr>
        </p:nvGraphicFramePr>
        <p:xfrm>
          <a:off x="761999" y="5055869"/>
          <a:ext cx="3200400" cy="952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6275">
                  <a:extLst>
                    <a:ext uri="{9D8B030D-6E8A-4147-A177-3AD203B41FA5}">
                      <a16:colId xmlns:a16="http://schemas.microsoft.com/office/drawing/2014/main" val="3942726228"/>
                    </a:ext>
                  </a:extLst>
                </a:gridCol>
                <a:gridCol w="828675">
                  <a:extLst>
                    <a:ext uri="{9D8B030D-6E8A-4147-A177-3AD203B41FA5}">
                      <a16:colId xmlns:a16="http://schemas.microsoft.com/office/drawing/2014/main" val="364305156"/>
                    </a:ext>
                  </a:extLst>
                </a:gridCol>
                <a:gridCol w="885825">
                  <a:extLst>
                    <a:ext uri="{9D8B030D-6E8A-4147-A177-3AD203B41FA5}">
                      <a16:colId xmlns:a16="http://schemas.microsoft.com/office/drawing/2014/main" val="3124684265"/>
                    </a:ext>
                  </a:extLst>
                </a:gridCol>
                <a:gridCol w="809625">
                  <a:extLst>
                    <a:ext uri="{9D8B030D-6E8A-4147-A177-3AD203B41FA5}">
                      <a16:colId xmlns:a16="http://schemas.microsoft.com/office/drawing/2014/main" val="372193406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er (ug/ml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</a:rPr>
                        <a:t>dimeris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almitoyl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76583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.412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78875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7.2788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0.88716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.0901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377905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1.34385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9.44747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2.1008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260239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6.92300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39837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3.0720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93670403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380FC03-BAFB-C851-70BF-6B9DAED048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3398463"/>
              </p:ext>
            </p:extLst>
          </p:nvPr>
        </p:nvGraphicFramePr>
        <p:xfrm>
          <a:off x="1487441" y="4211320"/>
          <a:ext cx="2832100" cy="571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53024">
                  <a:extLst>
                    <a:ext uri="{9D8B030D-6E8A-4147-A177-3AD203B41FA5}">
                      <a16:colId xmlns:a16="http://schemas.microsoft.com/office/drawing/2014/main" val="2161329275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2963482839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449429397"/>
                    </a:ext>
                  </a:extLst>
                </a:gridCol>
                <a:gridCol w="882076">
                  <a:extLst>
                    <a:ext uri="{9D8B030D-6E8A-4147-A177-3AD203B41FA5}">
                      <a16:colId xmlns:a16="http://schemas.microsoft.com/office/drawing/2014/main" val="30105040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941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9473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4298.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3173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036452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14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46735.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1560.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35.08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21573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0.887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9.447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0.2398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799592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F61C403-BC3E-895E-B48A-AF40673196DF}"/>
              </a:ext>
            </a:extLst>
          </p:cNvPr>
          <p:cNvSpPr txBox="1"/>
          <p:nvPr/>
        </p:nvSpPr>
        <p:spPr>
          <a:xfrm>
            <a:off x="199566" y="611297"/>
            <a:ext cx="2026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iginal data for Figure 5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766BBD-D197-EE4C-FD87-AB31C182E1F7}"/>
              </a:ext>
            </a:extLst>
          </p:cNvPr>
          <p:cNvSpPr txBox="1"/>
          <p:nvPr/>
        </p:nvSpPr>
        <p:spPr>
          <a:xfrm>
            <a:off x="289677" y="222488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39F3C53-719F-D8DC-C317-16BF7518D31A}"/>
              </a:ext>
            </a:extLst>
          </p:cNvPr>
          <p:cNvSpPr txBox="1"/>
          <p:nvPr/>
        </p:nvSpPr>
        <p:spPr>
          <a:xfrm>
            <a:off x="8660010" y="888296"/>
            <a:ext cx="1587234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imerisa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          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94DA86-8252-271C-C9BE-3EABBAD6B1CE}"/>
              </a:ext>
            </a:extLst>
          </p:cNvPr>
          <p:cNvSpPr txBox="1"/>
          <p:nvPr/>
        </p:nvSpPr>
        <p:spPr>
          <a:xfrm>
            <a:off x="8402587" y="1062974"/>
            <a:ext cx="2026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lmitoylation (          )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1CD7974-7472-DFAD-3E8F-A14A40FF76BA}"/>
              </a:ext>
            </a:extLst>
          </p:cNvPr>
          <p:cNvCxnSpPr/>
          <p:nvPr/>
        </p:nvCxnSpPr>
        <p:spPr>
          <a:xfrm>
            <a:off x="9670775" y="1047377"/>
            <a:ext cx="4174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9EACD4B-F332-E793-66CA-2F84278D2EF9}"/>
              </a:ext>
            </a:extLst>
          </p:cNvPr>
          <p:cNvCxnSpPr>
            <a:cxnSpLocks/>
          </p:cNvCxnSpPr>
          <p:nvPr/>
        </p:nvCxnSpPr>
        <p:spPr>
          <a:xfrm>
            <a:off x="9680714" y="1205188"/>
            <a:ext cx="417443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DBB3BE14-61B9-5B9E-656F-F0D02CF9B659}"/>
              </a:ext>
            </a:extLst>
          </p:cNvPr>
          <p:cNvSpPr txBox="1"/>
          <p:nvPr/>
        </p:nvSpPr>
        <p:spPr>
          <a:xfrm rot="16200000">
            <a:off x="2906405" y="3013332"/>
            <a:ext cx="4668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ercent (%) dimerization/palmitoylation</a:t>
            </a:r>
          </a:p>
        </p:txBody>
      </p:sp>
    </p:spTree>
    <p:extLst>
      <p:ext uri="{BB962C8B-B14F-4D97-AF65-F5344CB8AC3E}">
        <p14:creationId xmlns:p14="http://schemas.microsoft.com/office/powerpoint/2010/main" val="3131607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</TotalTime>
  <Words>428</Words>
  <Application>Microsoft Macintosh PowerPoint</Application>
  <PresentationFormat>Widescreen</PresentationFormat>
  <Paragraphs>36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attacharyya, Raja,Ph.D.</dc:creator>
  <cp:lastModifiedBy>Bhattacharyya, Raja,Ph.D.</cp:lastModifiedBy>
  <cp:revision>22</cp:revision>
  <dcterms:created xsi:type="dcterms:W3CDTF">2024-01-25T15:37:37Z</dcterms:created>
  <dcterms:modified xsi:type="dcterms:W3CDTF">2024-02-15T14:02:57Z</dcterms:modified>
</cp:coreProperties>
</file>